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84" r:id="rId1"/>
  </p:sldMasterIdLst>
  <p:sldIdLst>
    <p:sldId id="257" r:id="rId2"/>
  </p:sldIdLst>
  <p:sldSz cx="8640763" cy="11520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290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885414"/>
            <a:ext cx="7344649" cy="4010837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6050924"/>
            <a:ext cx="6480572" cy="2781450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0864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9726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613359"/>
            <a:ext cx="1863165" cy="976308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613359"/>
            <a:ext cx="5481484" cy="9763081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5564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235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2872125"/>
            <a:ext cx="7452658" cy="4792202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7709663"/>
            <a:ext cx="7452658" cy="2520106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/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8546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6702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613362"/>
            <a:ext cx="7452658" cy="222676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2824120"/>
            <a:ext cx="3655447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4208178"/>
            <a:ext cx="3655447" cy="618959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2824120"/>
            <a:ext cx="3673450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4208178"/>
            <a:ext cx="3673450" cy="618959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470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3710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3888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658740"/>
            <a:ext cx="4374386" cy="8187013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6668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658740"/>
            <a:ext cx="4374386" cy="8187013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7104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613362"/>
            <a:ext cx="7452658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3066796"/>
            <a:ext cx="7452658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118B8-D135-4F26-AA61-BC339FDE50F4}" type="datetimeFigureOut">
              <a:rPr lang="fr-FR" smtClean="0"/>
              <a:t>0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10677788"/>
            <a:ext cx="2916258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4463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0" name="ZoneTexte 369"/>
          <p:cNvSpPr txBox="1"/>
          <p:nvPr/>
        </p:nvSpPr>
        <p:spPr>
          <a:xfrm>
            <a:off x="233496" y="163195"/>
            <a:ext cx="840726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92901"/>
            <a:r>
              <a:rPr lang="en-US" sz="16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Molecular surveillance of EHV-1 strains circulating in France since a major 2009 outbreak in Normandy involving respiratory infection, neurological disorder and abortion.</a:t>
            </a:r>
            <a:endParaRPr lang="fr-FR" sz="1600" b="1" dirty="0">
              <a:solidFill>
                <a:prstClr val="black"/>
              </a:solidFill>
              <a:latin typeface="Palatino Linotype" panose="02040502050505030304" pitchFamily="18" charset="0"/>
            </a:endParaRPr>
          </a:p>
          <a:p>
            <a:pPr defTabSz="192901"/>
            <a:r>
              <a:rPr lang="en-US" sz="1600" dirty="0">
                <a:solidFill>
                  <a:prstClr val="black"/>
                </a:solidFill>
                <a:latin typeface="Palatino Linotype" panose="02040502050505030304" pitchFamily="18" charset="0"/>
              </a:rPr>
              <a:t>Gabrielle Sutton </a:t>
            </a:r>
            <a:r>
              <a:rPr lang="en-US" sz="1600" i="1" dirty="0">
                <a:solidFill>
                  <a:prstClr val="black"/>
                </a:solidFill>
                <a:latin typeface="Palatino Linotype" panose="02040502050505030304" pitchFamily="18" charset="0"/>
              </a:rPr>
              <a:t>et al</a:t>
            </a:r>
            <a:r>
              <a:rPr lang="en-US" sz="1600" dirty="0">
                <a:solidFill>
                  <a:prstClr val="black"/>
                </a:solidFill>
                <a:latin typeface="Palatino Linotype" panose="02040502050505030304" pitchFamily="18" charset="0"/>
              </a:rPr>
              <a:t>. Viruses.</a:t>
            </a:r>
            <a:endParaRPr lang="fr-FR" sz="1600" dirty="0">
              <a:solidFill>
                <a:prstClr val="black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809610" y="1783589"/>
            <a:ext cx="494026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dirty="0">
                <a:latin typeface="Palatino Linotype" panose="02040502050505030304" pitchFamily="18" charset="0"/>
              </a:rPr>
              <a:t>Supplementary Table </a:t>
            </a:r>
            <a:r>
              <a:rPr lang="en-GB" sz="1600" dirty="0" smtClean="0">
                <a:latin typeface="Palatino Linotype" panose="02040502050505030304" pitchFamily="18" charset="0"/>
              </a:rPr>
              <a:t>S3: </a:t>
            </a:r>
            <a:r>
              <a:rPr lang="en-US" sz="1600" dirty="0">
                <a:latin typeface="Palatino Linotype" panose="02040502050505030304" pitchFamily="18" charset="0"/>
              </a:rPr>
              <a:t>ORF30 sequencing Primers</a:t>
            </a:r>
            <a:endParaRPr lang="en-GB" sz="16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7404366"/>
              </p:ext>
            </p:extLst>
          </p:nvPr>
        </p:nvGraphicFramePr>
        <p:xfrm>
          <a:off x="374073" y="2493818"/>
          <a:ext cx="7772400" cy="3463636"/>
        </p:xfrm>
        <a:graphic>
          <a:graphicData uri="http://schemas.openxmlformats.org/drawingml/2006/table">
            <a:tbl>
              <a:tblPr firstRow="1" firstCol="1" bandRow="1"/>
              <a:tblGrid>
                <a:gridCol w="2616286">
                  <a:extLst>
                    <a:ext uri="{9D8B030D-6E8A-4147-A177-3AD203B41FA5}">
                      <a16:colId xmlns:a16="http://schemas.microsoft.com/office/drawing/2014/main" val="876250313"/>
                    </a:ext>
                  </a:extLst>
                </a:gridCol>
                <a:gridCol w="3861593">
                  <a:extLst>
                    <a:ext uri="{9D8B030D-6E8A-4147-A177-3AD203B41FA5}">
                      <a16:colId xmlns:a16="http://schemas.microsoft.com/office/drawing/2014/main" val="1401818546"/>
                    </a:ext>
                  </a:extLst>
                </a:gridCol>
                <a:gridCol w="1294521">
                  <a:extLst>
                    <a:ext uri="{9D8B030D-6E8A-4147-A177-3AD203B41FA5}">
                      <a16:colId xmlns:a16="http://schemas.microsoft.com/office/drawing/2014/main" val="1765253883"/>
                    </a:ext>
                  </a:extLst>
                </a:gridCol>
              </a:tblGrid>
              <a:tr h="28716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2344614"/>
                  </a:ext>
                </a:extLst>
              </a:tr>
              <a:tr h="29158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EHV-1.ORF30-PCR-F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AACGTGCGAGTGCTGTTTT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CR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263064"/>
                  </a:ext>
                </a:extLst>
              </a:tr>
              <a:tr h="29158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EHV-1.ORF30.PCR.RC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TGTGAAGGTCTGTTCGAC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CR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4652210"/>
                  </a:ext>
                </a:extLst>
              </a:tr>
              <a:tr h="29158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ORF30.F600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GGTTTTGGGCGGTACCGCGC 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9365086"/>
                  </a:ext>
                </a:extLst>
              </a:tr>
              <a:tr h="29158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ORF30-F1300 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AGCAGCTCGCGCGTCGCCCAACG 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780537"/>
                  </a:ext>
                </a:extLst>
              </a:tr>
              <a:tr h="287164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F30-F155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GTCGCGCAGCAGATGCCAGCAG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5016393"/>
                  </a:ext>
                </a:extLst>
              </a:tr>
              <a:tr h="287164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F30-AS80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TGGACGTGCGCGAGTTCG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7770286"/>
                  </a:ext>
                </a:extLst>
              </a:tr>
              <a:tr h="287164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F30-AS166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TATCCAGGCCCATAACCTC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7670041"/>
                  </a:ext>
                </a:extLst>
              </a:tr>
              <a:tr h="287164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F30-R190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GTGGGACATCGCCACGAAC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9158350"/>
                  </a:ext>
                </a:extLst>
              </a:tr>
              <a:tr h="287164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F30-R1-45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CGTGACCACGCGGCTGTTG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062767"/>
                  </a:ext>
                </a:extLst>
              </a:tr>
              <a:tr h="287164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HV-1-ORF30-PCR-R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AGAGACTTCGGAGAGCGC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8108923"/>
                  </a:ext>
                </a:extLst>
              </a:tr>
              <a:tr h="287164">
                <a:tc>
                  <a:txBody>
                    <a:bodyPr/>
                    <a:lstStyle/>
                    <a:p>
                      <a:pPr algn="l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F30-R-70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CTCCGG GGTTGCTGGCCTCG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67682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25794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75</Words>
  <Application>Microsoft Office PowerPoint</Application>
  <PresentationFormat>Personnalisé</PresentationFormat>
  <Paragraphs>3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Palatino Linotype</vt:lpstr>
      <vt:lpstr>Times New Roman</vt:lpstr>
      <vt:lpstr>1_Thème Office</vt:lpstr>
      <vt:lpstr>Présentation PowerPoint</vt:lpstr>
    </vt:vector>
  </TitlesOfParts>
  <Company>LABE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brielle SUTTON</dc:creator>
  <cp:lastModifiedBy>Gabrielle SUTTON</cp:lastModifiedBy>
  <cp:revision>3</cp:revision>
  <dcterms:created xsi:type="dcterms:W3CDTF">2019-08-08T12:00:46Z</dcterms:created>
  <dcterms:modified xsi:type="dcterms:W3CDTF">2019-08-08T12:16:06Z</dcterms:modified>
</cp:coreProperties>
</file>